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26EC10-E18B-4033-87DF-09EAD203A77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3EC239-C0F1-4055-8D88-DB8FFEBE16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DD21EA-F499-4A9D-9CEA-3FB48F76A9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A240EE-8CBF-485E-9D8E-017357B5D8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498879-855D-421C-9853-E198F2CF34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D27355-72BB-44D2-9164-5966065C4C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D52A13-D597-4F06-A71C-13E87F87C2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AF4EEF-25AE-4C94-8755-5A1D67B451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C9BF3F-C7C8-49EB-8D3D-AF7FAC6413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ADC74E-5AA5-4239-ADA1-1CE4395A29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90CAD9-8ABD-4A0E-8063-67CF8132EB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390AA8-38DF-45AE-83FE-334ED8FF25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D02C49-4127-4A8E-A3AA-BF0FCCCFC45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0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/>
          </p:nvPr>
        </p:nvSpPr>
        <p:spPr>
          <a:xfrm>
            <a:off x="76320" y="5176440"/>
            <a:ext cx="8470800" cy="12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5000"/>
          </a:bodyPr>
          <a:p>
            <a:pPr marL="291600" indent="0" algn="just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Supplemental Figure S9. Differential expression of genes in the canonical FAK (focal adhesion kinase) signaling pathway.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Genes are represented as nodes, biological relationships between two nodes as lines; nodes are displayed using various shapes that represent the functional class of the gene product. The intensity of the node color indicates the degree of up- (red) or down- (green) regulation in CRI-G1-RS cells relative to CRI-G1-RR cells; gray node color indicates genes showing no differential expression between RR and RS cells, while white node color marks genes that were not present on the array. Protein complexes/gene groups are indicated by nodes with double outlines; color shading within such a node indicates that genes within the complex/gene group showed different expression changes. The analysis was performed on 3917 probes with FDR-adjusted p-value ≤ 0.001, regardless of the fold change. When multiple probes were present for a single gene, the probe with the smallest p-value was used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1351080" y="217440"/>
            <a:ext cx="6149880" cy="4748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19T19:02:02Z</dcterms:created>
  <dc:creator>Marta Margeta</dc:creator>
  <dc:description/>
  <dc:language>en-US</dc:language>
  <cp:lastModifiedBy>Marta Margeta</cp:lastModifiedBy>
  <dcterms:modified xsi:type="dcterms:W3CDTF">2010-06-28T21:52:34Z</dcterms:modified>
  <cp:revision>4</cp:revision>
  <dc:subject/>
  <dc:title>Slide 1</dc:title>
</cp:coreProperties>
</file>